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124200" y="2362200"/>
            <a:ext cx="2822575" cy="1354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895600" y="1219200"/>
            <a:ext cx="343614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7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number of differentially expressed transcripts between any two successive sub-apical internodes of bioenergy sorghum genotype R.0702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t1 is the youngest sub-apical and Int4 is the oldest internode. </a:t>
            </a:r>
            <a:endParaRPr lang="en-US" sz="1200" b="1" dirty="0" smtClean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2638720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3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5:26Z</dcterms:modified>
</cp:coreProperties>
</file>